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74880F-B788-006B-B966-6198D58696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E4AA206-2A0A-8880-CB9A-7901CD4713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F6BBBBE-85E4-C50C-5E8F-D9916B39F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DC5D7D4-B756-01E6-889D-D1EC8AEA5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0B89C32-5A2D-004E-557A-98472DEAA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860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474F67-D8EE-214E-EE42-4CCE8B6FB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0A2ECA9-D22F-F595-A4A0-253C79C72A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0B71BF-7720-912C-B618-D9A6FB309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43B4811-F311-C8A0-29D2-72E59E5AC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E387408-999E-FF2A-651C-B7975B91A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721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220F274-BFB7-2E3F-1CD8-965E6712AB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E3E74D2-9977-BCE4-7DB8-E7F9D5F46A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6A82A-7B52-E046-2B43-6086DB6C2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87383FC-A95F-A205-6C88-C834FFCBE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CE4D06-FEC3-43DD-2311-255E246F74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954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30D151-AAA2-3176-D7D9-93A2BC908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F245007-F992-A9A6-2BB9-4FB8908D11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9930B09-E8ED-9A02-7F55-21EAC5D8A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7C23C39-68E9-FAFF-58F4-34FFBA417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80686AC-B92A-CFFF-974F-65D3FC0C8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343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34938E-53C1-35BB-EA9F-F387CBEE5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5310EE8-DAB2-9464-663D-3DF900EE04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CE6D096-9958-6618-8BC1-B393C3291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43287E9-4136-644E-50A5-08D1BCE42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1664CD-7D4B-A7B4-310B-77040A63D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9706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E5D21F-15FB-A313-3BE8-7C521E688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0A9CDF0-B121-914B-6389-5AE4FBE1E6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A40464E-FF3A-4E19-5785-C3F52AC92A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DF75F87-189F-1884-C0CB-0AFD5C0CF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B338A0A-FABE-1D86-AE99-D5F6846AD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1A7A813-A755-662E-344E-466B515D0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139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C418AB-4ED2-768D-C41C-0B49673EC3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E83B98D-32E4-12B8-87DA-13D0B6413A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9A916E1-3074-CD2A-5CB7-FD821DBE1E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846EACF-DC97-9716-4C7D-B03BD297EC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20CA5C9-1969-C8DC-17DA-AB9184CA4E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393CAA4-F03C-9E4E-6CB2-3894C71EB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B81D129-27D9-9F64-0D63-37E156DB3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7A9C9AA-D055-DB14-4FE7-B26DE09B2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9651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B691CD-F2D2-0CE9-C1F8-99648ED3D4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6DBFE6A-8BA6-6F0C-C63D-C309D5DB7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10CDA08-ECEA-2A2C-8617-EC66B5019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0ACE485-D673-C193-D843-595F1A9B0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1378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DFFD2E7-85BB-0C54-F348-1DA85759A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A7E827-60D5-38B3-C71C-8C78DC1C0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C0B1D6E-ACD0-4BD9-52F8-B12871E19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282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3E5A8C-7AD3-9CA8-7726-D7F06954C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519EF70-4DF1-FC2E-3E9A-F30F0D14B0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A4F3AA5-ED0E-8C9C-E01D-03954A2262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536127D-8875-78F6-0F3B-99C60E532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95E4CE2-6349-67D8-FC78-B45645770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42BAD18-0335-9778-B794-36827222F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785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5B6D10-AE32-7F97-D2D2-FE356A6BE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9BE67C7-9410-104B-1C01-0B45D0DB4E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27AD99A-529A-B2F9-DCA9-AEFAF9CA1F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EA4390E-851A-6358-D671-CC059F4AF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E120AA-B2A8-E1EF-2256-5C2C23B33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31E11D2-1F36-9A16-9F87-D6043E282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14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C1DC28C-7CD6-47B2-E90D-200D6D346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C12188-0444-32CD-8805-A71A4C65D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C3C26D-9E0D-E1F6-C724-D49144EDF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A0948-4F40-4683-A2C6-0E082BB75D5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A23F94-5831-1303-DF58-6FF9A8DBEB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3BA1ADB-05FC-B136-6CE7-4D939E864B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8E9BC-7E38-41BF-A90C-6693B2FDF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7954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ttangolo 7">
            <a:extLst>
              <a:ext uri="{FF2B5EF4-FFF2-40B4-BE49-F238E27FC236}">
                <a16:creationId xmlns:a16="http://schemas.microsoft.com/office/drawing/2014/main" id="{45FC0158-F178-ECF5-5D55-6DD7E15E7FD9}"/>
              </a:ext>
            </a:extLst>
          </p:cNvPr>
          <p:cNvSpPr/>
          <p:nvPr/>
        </p:nvSpPr>
        <p:spPr>
          <a:xfrm>
            <a:off x="3870036" y="1099127"/>
            <a:ext cx="4135735" cy="1847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A3CC56A-74DA-6700-EB70-B408DDE21BF8}"/>
              </a:ext>
            </a:extLst>
          </p:cNvPr>
          <p:cNvSpPr txBox="1"/>
          <p:nvPr/>
        </p:nvSpPr>
        <p:spPr>
          <a:xfrm>
            <a:off x="2782641" y="5181690"/>
            <a:ext cx="61682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erficial scald incidence in ‘Granny Smith’ and ‘Ladina’ after storage.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= Regular Atmosphere; 1-MCP= Regular Atmosphere + 1-MCP treatment; LO= Low Oxygen.</a:t>
            </a:r>
          </a:p>
          <a:p>
            <a:endParaRPr lang="en-GB" sz="1200" dirty="0"/>
          </a:p>
        </p:txBody>
      </p:sp>
      <p:grpSp>
        <p:nvGrpSpPr>
          <p:cNvPr id="86" name="Gruppo 85">
            <a:extLst>
              <a:ext uri="{FF2B5EF4-FFF2-40B4-BE49-F238E27FC236}">
                <a16:creationId xmlns:a16="http://schemas.microsoft.com/office/drawing/2014/main" id="{543FD73E-CEAB-C42B-62E6-CE12D893DC15}"/>
              </a:ext>
            </a:extLst>
          </p:cNvPr>
          <p:cNvGrpSpPr/>
          <p:nvPr/>
        </p:nvGrpSpPr>
        <p:grpSpPr>
          <a:xfrm>
            <a:off x="2782642" y="743369"/>
            <a:ext cx="6170289" cy="4296581"/>
            <a:chOff x="3292159" y="870527"/>
            <a:chExt cx="4553071" cy="4296581"/>
          </a:xfrm>
        </p:grpSpPr>
        <p:grpSp>
          <p:nvGrpSpPr>
            <p:cNvPr id="12" name="Group 4">
              <a:extLst>
                <a:ext uri="{FF2B5EF4-FFF2-40B4-BE49-F238E27FC236}">
                  <a16:creationId xmlns:a16="http://schemas.microsoft.com/office/drawing/2014/main" id="{2F9A81A3-ED54-5D3F-7FA8-B3ADC46D5F4F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292159" y="870527"/>
              <a:ext cx="4553071" cy="4296581"/>
              <a:chOff x="2045" y="510"/>
              <a:chExt cx="3000" cy="2831"/>
            </a:xfrm>
          </p:grpSpPr>
          <p:sp>
            <p:nvSpPr>
              <p:cNvPr id="14" name="Rectangle 5">
                <a:extLst>
                  <a:ext uri="{FF2B5EF4-FFF2-40B4-BE49-F238E27FC236}">
                    <a16:creationId xmlns:a16="http://schemas.microsoft.com/office/drawing/2014/main" id="{40CEFB22-96E0-7235-72E6-450CF6E561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0" y="516"/>
                <a:ext cx="2945" cy="276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" name="Rectangle 6">
                <a:extLst>
                  <a:ext uri="{FF2B5EF4-FFF2-40B4-BE49-F238E27FC236}">
                    <a16:creationId xmlns:a16="http://schemas.microsoft.com/office/drawing/2014/main" id="{278378C3-06E1-7FBE-73A3-1998161D10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9" y="516"/>
                <a:ext cx="2945" cy="2764"/>
              </a:xfrm>
              <a:prstGeom prst="rect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" name="Rectangle 7">
                <a:extLst>
                  <a:ext uri="{FF2B5EF4-FFF2-40B4-BE49-F238E27FC236}">
                    <a16:creationId xmlns:a16="http://schemas.microsoft.com/office/drawing/2014/main" id="{4C37B0AD-9FD2-2EB4-3ECE-E9864A3427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07" y="743"/>
                <a:ext cx="1339" cy="23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Line 8">
                <a:extLst>
                  <a:ext uri="{FF2B5EF4-FFF2-40B4-BE49-F238E27FC236}">
                    <a16:creationId xmlns:a16="http://schemas.microsoft.com/office/drawing/2014/main" id="{DBF7F489-0EA7-47A6-B5D7-108414325C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7" y="2726"/>
                <a:ext cx="1339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" name="Line 9">
                <a:extLst>
                  <a:ext uri="{FF2B5EF4-FFF2-40B4-BE49-F238E27FC236}">
                    <a16:creationId xmlns:a16="http://schemas.microsoft.com/office/drawing/2014/main" id="{C03BF943-0D85-0CC8-6BB1-C5545ECB00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7" y="2190"/>
                <a:ext cx="1339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Line 10">
                <a:extLst>
                  <a:ext uri="{FF2B5EF4-FFF2-40B4-BE49-F238E27FC236}">
                    <a16:creationId xmlns:a16="http://schemas.microsoft.com/office/drawing/2014/main" id="{C43EF212-70C8-90BD-3001-99F312CB4F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7" y="1655"/>
                <a:ext cx="1339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" name="Line 11">
                <a:extLst>
                  <a:ext uri="{FF2B5EF4-FFF2-40B4-BE49-F238E27FC236}">
                    <a16:creationId xmlns:a16="http://schemas.microsoft.com/office/drawing/2014/main" id="{A1373898-7792-AA8C-D07B-1ACEE06D0F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7" y="1119"/>
                <a:ext cx="1339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Freeform 12">
                <a:extLst>
                  <a:ext uri="{FF2B5EF4-FFF2-40B4-BE49-F238E27FC236}">
                    <a16:creationId xmlns:a16="http://schemas.microsoft.com/office/drawing/2014/main" id="{57849936-6638-2D27-D078-C102DB80C3C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11" y="2994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" name="Freeform 13">
                <a:extLst>
                  <a:ext uri="{FF2B5EF4-FFF2-40B4-BE49-F238E27FC236}">
                    <a16:creationId xmlns:a16="http://schemas.microsoft.com/office/drawing/2014/main" id="{D21F70A9-9F49-2559-C5EC-AEA822C343E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11" y="2458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Freeform 14">
                <a:extLst>
                  <a:ext uri="{FF2B5EF4-FFF2-40B4-BE49-F238E27FC236}">
                    <a16:creationId xmlns:a16="http://schemas.microsoft.com/office/drawing/2014/main" id="{F418182A-01DB-B58D-DFD3-AAB94EB905C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11" y="1922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Freeform 15">
                <a:extLst>
                  <a:ext uri="{FF2B5EF4-FFF2-40B4-BE49-F238E27FC236}">
                    <a16:creationId xmlns:a16="http://schemas.microsoft.com/office/drawing/2014/main" id="{D554B13F-FFC0-AB0E-A9B6-A4A6327C400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11" y="1387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Freeform 16">
                <a:extLst>
                  <a:ext uri="{FF2B5EF4-FFF2-40B4-BE49-F238E27FC236}">
                    <a16:creationId xmlns:a16="http://schemas.microsoft.com/office/drawing/2014/main" id="{369DE786-0118-3E08-A5EA-EDB18091F53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11" y="851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" name="Line 17">
                <a:extLst>
                  <a:ext uri="{FF2B5EF4-FFF2-40B4-BE49-F238E27FC236}">
                    <a16:creationId xmlns:a16="http://schemas.microsoft.com/office/drawing/2014/main" id="{FA5C9358-1C43-ECA1-E7D7-5F073EC9E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6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" name="Line 18">
                <a:extLst>
                  <a:ext uri="{FF2B5EF4-FFF2-40B4-BE49-F238E27FC236}">
                    <a16:creationId xmlns:a16="http://schemas.microsoft.com/office/drawing/2014/main" id="{5EC0684C-22A6-4315-E8FA-26F8045D05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7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" name="Line 19">
                <a:extLst>
                  <a:ext uri="{FF2B5EF4-FFF2-40B4-BE49-F238E27FC236}">
                    <a16:creationId xmlns:a16="http://schemas.microsoft.com/office/drawing/2014/main" id="{59E02584-73ED-725B-227E-B09F7098D5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93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" name="Rectangle 20">
                <a:extLst>
                  <a:ext uri="{FF2B5EF4-FFF2-40B4-BE49-F238E27FC236}">
                    <a16:creationId xmlns:a16="http://schemas.microsoft.com/office/drawing/2014/main" id="{65F52089-A8F2-ED00-E4EF-8571C5FFBE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2" y="1495"/>
                <a:ext cx="209" cy="1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" name="Rectangle 21">
                <a:extLst>
                  <a:ext uri="{FF2B5EF4-FFF2-40B4-BE49-F238E27FC236}">
                    <a16:creationId xmlns:a16="http://schemas.microsoft.com/office/drawing/2014/main" id="{B45A13C0-5913-7502-7102-EAFA0DBA5A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2" y="1495"/>
                <a:ext cx="209" cy="1499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" name="Rectangle 22">
                <a:extLst>
                  <a:ext uri="{FF2B5EF4-FFF2-40B4-BE49-F238E27FC236}">
                    <a16:creationId xmlns:a16="http://schemas.microsoft.com/office/drawing/2014/main" id="{903EEC25-FEC2-0FB3-6C43-1D8B1F33E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" y="2972"/>
                <a:ext cx="212" cy="2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" name="Rectangle 23">
                <a:extLst>
                  <a:ext uri="{FF2B5EF4-FFF2-40B4-BE49-F238E27FC236}">
                    <a16:creationId xmlns:a16="http://schemas.microsoft.com/office/drawing/2014/main" id="{F00D2AAB-ECB7-3550-5A30-3CD42EA393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" y="2972"/>
                <a:ext cx="212" cy="22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" name="Rectangle 24">
                <a:extLst>
                  <a:ext uri="{FF2B5EF4-FFF2-40B4-BE49-F238E27FC236}">
                    <a16:creationId xmlns:a16="http://schemas.microsoft.com/office/drawing/2014/main" id="{03F9E289-C419-5CCA-5D57-3E7100CB59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9" y="2972"/>
                <a:ext cx="208" cy="2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" name="Rectangle 25">
                <a:extLst>
                  <a:ext uri="{FF2B5EF4-FFF2-40B4-BE49-F238E27FC236}">
                    <a16:creationId xmlns:a16="http://schemas.microsoft.com/office/drawing/2014/main" id="{66D919CF-1F3F-709E-A070-64B5E94B7B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9" y="2972"/>
                <a:ext cx="208" cy="22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" name="Rectangle 26">
                <a:extLst>
                  <a:ext uri="{FF2B5EF4-FFF2-40B4-BE49-F238E27FC236}">
                    <a16:creationId xmlns:a16="http://schemas.microsoft.com/office/drawing/2014/main" id="{B40A77E7-4517-AA90-B814-7EEAFD10F2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76" y="743"/>
                <a:ext cx="1338" cy="23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" name="Line 27">
                <a:extLst>
                  <a:ext uri="{FF2B5EF4-FFF2-40B4-BE49-F238E27FC236}">
                    <a16:creationId xmlns:a16="http://schemas.microsoft.com/office/drawing/2014/main" id="{64E14D5A-0904-3A4B-6BE7-A2F7D52447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6" y="2726"/>
                <a:ext cx="1338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" name="Line 28">
                <a:extLst>
                  <a:ext uri="{FF2B5EF4-FFF2-40B4-BE49-F238E27FC236}">
                    <a16:creationId xmlns:a16="http://schemas.microsoft.com/office/drawing/2014/main" id="{0877090B-A3B8-AB46-D68C-DB83C91B37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6" y="2190"/>
                <a:ext cx="1338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" name="Line 29">
                <a:extLst>
                  <a:ext uri="{FF2B5EF4-FFF2-40B4-BE49-F238E27FC236}">
                    <a16:creationId xmlns:a16="http://schemas.microsoft.com/office/drawing/2014/main" id="{0C166ADE-596B-1019-6765-37C2C4A028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6" y="1655"/>
                <a:ext cx="1338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" name="Line 30">
                <a:extLst>
                  <a:ext uri="{FF2B5EF4-FFF2-40B4-BE49-F238E27FC236}">
                    <a16:creationId xmlns:a16="http://schemas.microsoft.com/office/drawing/2014/main" id="{79F44BDF-52E2-75BF-4068-162A6E9DDF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6" y="1119"/>
                <a:ext cx="1338" cy="0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" name="Freeform 31">
                <a:extLst>
                  <a:ext uri="{FF2B5EF4-FFF2-40B4-BE49-F238E27FC236}">
                    <a16:creationId xmlns:a16="http://schemas.microsoft.com/office/drawing/2014/main" id="{4689D4A4-807C-709A-F205-622CE7A873E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79" y="2994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" name="Freeform 32">
                <a:extLst>
                  <a:ext uri="{FF2B5EF4-FFF2-40B4-BE49-F238E27FC236}">
                    <a16:creationId xmlns:a16="http://schemas.microsoft.com/office/drawing/2014/main" id="{A6C8730B-5198-9897-217D-7800E5006D3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79" y="2458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" name="Freeform 33">
                <a:extLst>
                  <a:ext uri="{FF2B5EF4-FFF2-40B4-BE49-F238E27FC236}">
                    <a16:creationId xmlns:a16="http://schemas.microsoft.com/office/drawing/2014/main" id="{5772B1FC-70AA-D11B-BDA7-7E8D24FF6E7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79" y="1922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" name="Freeform 34">
                <a:extLst>
                  <a:ext uri="{FF2B5EF4-FFF2-40B4-BE49-F238E27FC236}">
                    <a16:creationId xmlns:a16="http://schemas.microsoft.com/office/drawing/2014/main" id="{314EFD5F-FE83-6FF4-F843-CAA32432737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79" y="1387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" name="Freeform 35">
                <a:extLst>
                  <a:ext uri="{FF2B5EF4-FFF2-40B4-BE49-F238E27FC236}">
                    <a16:creationId xmlns:a16="http://schemas.microsoft.com/office/drawing/2014/main" id="{F821048B-611E-31CA-6195-0CC308CF4DC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79" y="851"/>
                <a:ext cx="1335" cy="0"/>
              </a:xfrm>
              <a:custGeom>
                <a:avLst/>
                <a:gdLst>
                  <a:gd name="T0" fmla="*/ 4 w 359"/>
                  <a:gd name="T1" fmla="*/ 11 w 359"/>
                  <a:gd name="T2" fmla="*/ 16 w 359"/>
                  <a:gd name="T3" fmla="*/ 23 w 359"/>
                  <a:gd name="T4" fmla="*/ 28 w 359"/>
                  <a:gd name="T5" fmla="*/ 35 w 359"/>
                  <a:gd name="T6" fmla="*/ 40 w 359"/>
                  <a:gd name="T7" fmla="*/ 47 w 359"/>
                  <a:gd name="T8" fmla="*/ 52 w 359"/>
                  <a:gd name="T9" fmla="*/ 59 w 359"/>
                  <a:gd name="T10" fmla="*/ 64 w 359"/>
                  <a:gd name="T11" fmla="*/ 71 w 359"/>
                  <a:gd name="T12" fmla="*/ 76 w 359"/>
                  <a:gd name="T13" fmla="*/ 83 w 359"/>
                  <a:gd name="T14" fmla="*/ 88 w 359"/>
                  <a:gd name="T15" fmla="*/ 95 w 359"/>
                  <a:gd name="T16" fmla="*/ 100 w 359"/>
                  <a:gd name="T17" fmla="*/ 107 w 359"/>
                  <a:gd name="T18" fmla="*/ 112 w 359"/>
                  <a:gd name="T19" fmla="*/ 119 w 359"/>
                  <a:gd name="T20" fmla="*/ 124 w 359"/>
                  <a:gd name="T21" fmla="*/ 131 w 359"/>
                  <a:gd name="T22" fmla="*/ 136 w 359"/>
                  <a:gd name="T23" fmla="*/ 143 w 359"/>
                  <a:gd name="T24" fmla="*/ 148 w 359"/>
                  <a:gd name="T25" fmla="*/ 155 w 359"/>
                  <a:gd name="T26" fmla="*/ 160 w 359"/>
                  <a:gd name="T27" fmla="*/ 167 w 359"/>
                  <a:gd name="T28" fmla="*/ 172 w 359"/>
                  <a:gd name="T29" fmla="*/ 179 w 359"/>
                  <a:gd name="T30" fmla="*/ 184 w 359"/>
                  <a:gd name="T31" fmla="*/ 191 w 359"/>
                  <a:gd name="T32" fmla="*/ 196 w 359"/>
                  <a:gd name="T33" fmla="*/ 203 w 359"/>
                  <a:gd name="T34" fmla="*/ 208 w 359"/>
                  <a:gd name="T35" fmla="*/ 215 w 359"/>
                  <a:gd name="T36" fmla="*/ 220 w 359"/>
                  <a:gd name="T37" fmla="*/ 227 w 359"/>
                  <a:gd name="T38" fmla="*/ 232 w 359"/>
                  <a:gd name="T39" fmla="*/ 239 w 359"/>
                  <a:gd name="T40" fmla="*/ 244 w 359"/>
                  <a:gd name="T41" fmla="*/ 251 w 359"/>
                  <a:gd name="T42" fmla="*/ 256 w 359"/>
                  <a:gd name="T43" fmla="*/ 263 w 359"/>
                  <a:gd name="T44" fmla="*/ 268 w 359"/>
                  <a:gd name="T45" fmla="*/ 275 w 359"/>
                  <a:gd name="T46" fmla="*/ 280 w 359"/>
                  <a:gd name="T47" fmla="*/ 287 w 359"/>
                  <a:gd name="T48" fmla="*/ 292 w 359"/>
                  <a:gd name="T49" fmla="*/ 299 w 359"/>
                  <a:gd name="T50" fmla="*/ 304 w 359"/>
                  <a:gd name="T51" fmla="*/ 311 w 359"/>
                  <a:gd name="T52" fmla="*/ 316 w 359"/>
                  <a:gd name="T53" fmla="*/ 323 w 359"/>
                  <a:gd name="T54" fmla="*/ 328 w 359"/>
                  <a:gd name="T55" fmla="*/ 335 w 359"/>
                  <a:gd name="T56" fmla="*/ 340 w 359"/>
                  <a:gd name="T57" fmla="*/ 347 w 359"/>
                  <a:gd name="T58" fmla="*/ 352 w 35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</a:cxnLst>
                <a:rect l="0" t="0" r="r" b="b"/>
                <a:pathLst>
                  <a:path w="359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</a:path>
                </a:pathLst>
              </a:custGeom>
              <a:noFill/>
              <a:ln w="6350" cap="flat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" name="Line 36">
                <a:extLst>
                  <a:ext uri="{FF2B5EF4-FFF2-40B4-BE49-F238E27FC236}">
                    <a16:creationId xmlns:a16="http://schemas.microsoft.com/office/drawing/2014/main" id="{A4EA48FE-AAD4-2B31-2C6F-5FF77B163F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25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" name="Line 37">
                <a:extLst>
                  <a:ext uri="{FF2B5EF4-FFF2-40B4-BE49-F238E27FC236}">
                    <a16:creationId xmlns:a16="http://schemas.microsoft.com/office/drawing/2014/main" id="{94699C10-146D-18FE-C748-44D72C6C32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45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" name="Line 38">
                <a:extLst>
                  <a:ext uri="{FF2B5EF4-FFF2-40B4-BE49-F238E27FC236}">
                    <a16:creationId xmlns:a16="http://schemas.microsoft.com/office/drawing/2014/main" id="{053E99FB-C406-2A4F-D56F-4F9CC1BA39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62" y="743"/>
                <a:ext cx="0" cy="2355"/>
              </a:xfrm>
              <a:prstGeom prst="line">
                <a:avLst/>
              </a:prstGeom>
              <a:noFill/>
              <a:ln w="635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" name="Rectangle 39">
                <a:extLst>
                  <a:ext uri="{FF2B5EF4-FFF2-40B4-BE49-F238E27FC236}">
                    <a16:creationId xmlns:a16="http://schemas.microsoft.com/office/drawing/2014/main" id="{32AA6766-2641-46F3-CEF0-A58A325F11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1" y="851"/>
                <a:ext cx="208" cy="2143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" name="Rectangle 40">
                <a:extLst>
                  <a:ext uri="{FF2B5EF4-FFF2-40B4-BE49-F238E27FC236}">
                    <a16:creationId xmlns:a16="http://schemas.microsoft.com/office/drawing/2014/main" id="{CE35D49C-64D9-5E35-667F-A0FCDE7B0C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1" y="851"/>
                <a:ext cx="208" cy="2143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" name="Rectangle 41">
                <a:extLst>
                  <a:ext uri="{FF2B5EF4-FFF2-40B4-BE49-F238E27FC236}">
                    <a16:creationId xmlns:a16="http://schemas.microsoft.com/office/drawing/2014/main" id="{8BC951A9-76BB-2A4D-3F19-EB992C42B9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7" y="2562"/>
                <a:ext cx="212" cy="432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" name="Rectangle 42">
                <a:extLst>
                  <a:ext uri="{FF2B5EF4-FFF2-40B4-BE49-F238E27FC236}">
                    <a16:creationId xmlns:a16="http://schemas.microsoft.com/office/drawing/2014/main" id="{62F1812E-9869-B36A-64E6-68DC697774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7" y="2562"/>
                <a:ext cx="212" cy="432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" name="Rectangle 43">
                <a:extLst>
                  <a:ext uri="{FF2B5EF4-FFF2-40B4-BE49-F238E27FC236}">
                    <a16:creationId xmlns:a16="http://schemas.microsoft.com/office/drawing/2014/main" id="{3A0126CF-1B32-7EC8-F76D-079CD13F88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7" y="2800"/>
                <a:ext cx="209" cy="194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" name="Rectangle 44">
                <a:extLst>
                  <a:ext uri="{FF2B5EF4-FFF2-40B4-BE49-F238E27FC236}">
                    <a16:creationId xmlns:a16="http://schemas.microsoft.com/office/drawing/2014/main" id="{A6558A4D-FD72-91AF-943D-913B76E933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7" y="2800"/>
                <a:ext cx="209" cy="194"/>
              </a:xfrm>
              <a:prstGeom prst="rect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" name="Rectangle 46">
                <a:extLst>
                  <a:ext uri="{FF2B5EF4-FFF2-40B4-BE49-F238E27FC236}">
                    <a16:creationId xmlns:a16="http://schemas.microsoft.com/office/drawing/2014/main" id="{331700D9-5119-E09B-3F7B-F015A50B05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2" y="687"/>
                <a:ext cx="476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err="1">
                    <a:ln>
                      <a:noFill/>
                    </a:ln>
                    <a:solidFill>
                      <a:srgbClr val="1A1A1A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anny</a:t>
                </a:r>
                <a:r>
                  <a:rPr kumimoji="0" lang="it-IT" altLang="it-IT" sz="1000" b="0" i="0" u="none" strike="noStrike" cap="none" normalizeH="0" baseline="0" dirty="0">
                    <a:ln>
                      <a:noFill/>
                    </a:ln>
                    <a:solidFill>
                      <a:srgbClr val="1A1A1A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mith</a:t>
                </a:r>
                <a:endPara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Rectangle 48">
                <a:extLst>
                  <a:ext uri="{FF2B5EF4-FFF2-40B4-BE49-F238E27FC236}">
                    <a16:creationId xmlns:a16="http://schemas.microsoft.com/office/drawing/2014/main" id="{973BA0D2-6F5A-4155-1468-5B7B27E975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5" y="690"/>
                <a:ext cx="236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>
                    <a:ln>
                      <a:noFill/>
                    </a:ln>
                    <a:solidFill>
                      <a:srgbClr val="1A1A1A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dina</a:t>
                </a:r>
                <a:endPara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Line 49">
                <a:extLst>
                  <a:ext uri="{FF2B5EF4-FFF2-40B4-BE49-F238E27FC236}">
                    <a16:creationId xmlns:a16="http://schemas.microsoft.com/office/drawing/2014/main" id="{E2BC2C34-3AA1-4FE4-5047-1C5470B17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6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" name="Line 50">
                <a:extLst>
                  <a:ext uri="{FF2B5EF4-FFF2-40B4-BE49-F238E27FC236}">
                    <a16:creationId xmlns:a16="http://schemas.microsoft.com/office/drawing/2014/main" id="{D9B4DCEB-CA9D-1AEC-CB08-8B5066EE94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7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" name="Line 51">
                <a:extLst>
                  <a:ext uri="{FF2B5EF4-FFF2-40B4-BE49-F238E27FC236}">
                    <a16:creationId xmlns:a16="http://schemas.microsoft.com/office/drawing/2014/main" id="{B950482A-5FB1-B00D-D566-82ED501485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93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" name="Rectangle 52">
                <a:extLst>
                  <a:ext uri="{FF2B5EF4-FFF2-40B4-BE49-F238E27FC236}">
                    <a16:creationId xmlns:a16="http://schemas.microsoft.com/office/drawing/2014/main" id="{EAE83916-D386-4CE8-E6E2-C20A9454F2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2" y="3128"/>
                <a:ext cx="9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</a:t>
                </a:r>
              </a:p>
            </p:txBody>
          </p:sp>
          <p:sp>
            <p:nvSpPr>
              <p:cNvPr id="62" name="Rectangle 53">
                <a:extLst>
                  <a:ext uri="{FF2B5EF4-FFF2-40B4-BE49-F238E27FC236}">
                    <a16:creationId xmlns:a16="http://schemas.microsoft.com/office/drawing/2014/main" id="{4CFE0F1E-3751-E8B1-962D-D4B82DD715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2" y="3128"/>
                <a:ext cx="19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-MCP</a:t>
                </a:r>
              </a:p>
            </p:txBody>
          </p:sp>
          <p:sp>
            <p:nvSpPr>
              <p:cNvPr id="63" name="Rectangle 54">
                <a:extLst>
                  <a:ext uri="{FF2B5EF4-FFF2-40B4-BE49-F238E27FC236}">
                    <a16:creationId xmlns:a16="http://schemas.microsoft.com/office/drawing/2014/main" id="{C2E0B2C9-E452-4A0A-B6D0-C3FAC86325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0" y="3128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</a:t>
                </a:r>
              </a:p>
            </p:txBody>
          </p:sp>
          <p:sp>
            <p:nvSpPr>
              <p:cNvPr id="64" name="Line 55">
                <a:extLst>
                  <a:ext uri="{FF2B5EF4-FFF2-40B4-BE49-F238E27FC236}">
                    <a16:creationId xmlns:a16="http://schemas.microsoft.com/office/drawing/2014/main" id="{F305C896-BFAE-DD74-8BE7-6792AC627C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25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" name="Line 56">
                <a:extLst>
                  <a:ext uri="{FF2B5EF4-FFF2-40B4-BE49-F238E27FC236}">
                    <a16:creationId xmlns:a16="http://schemas.microsoft.com/office/drawing/2014/main" id="{C8AE0B41-9C01-6AC4-C4F9-720D151E51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45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" name="Line 57">
                <a:extLst>
                  <a:ext uri="{FF2B5EF4-FFF2-40B4-BE49-F238E27FC236}">
                    <a16:creationId xmlns:a16="http://schemas.microsoft.com/office/drawing/2014/main" id="{EF14CFD1-3759-2983-5022-729BFB1C2B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62" y="3098"/>
                <a:ext cx="0" cy="15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" name="Rectangle 58">
                <a:extLst>
                  <a:ext uri="{FF2B5EF4-FFF2-40B4-BE49-F238E27FC236}">
                    <a16:creationId xmlns:a16="http://schemas.microsoft.com/office/drawing/2014/main" id="{C1B0B8CC-2B61-8275-ECF9-EFC5576539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" y="3128"/>
                <a:ext cx="9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</a:t>
                </a:r>
              </a:p>
            </p:txBody>
          </p:sp>
          <p:sp>
            <p:nvSpPr>
              <p:cNvPr id="68" name="Rectangle 59">
                <a:extLst>
                  <a:ext uri="{FF2B5EF4-FFF2-40B4-BE49-F238E27FC236}">
                    <a16:creationId xmlns:a16="http://schemas.microsoft.com/office/drawing/2014/main" id="{B1A061AA-082E-1BB2-64EC-785DEB4A4F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60" y="3128"/>
                <a:ext cx="19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-MCP</a:t>
                </a:r>
              </a:p>
            </p:txBody>
          </p:sp>
          <p:sp>
            <p:nvSpPr>
              <p:cNvPr id="69" name="Rectangle 60">
                <a:extLst>
                  <a:ext uri="{FF2B5EF4-FFF2-40B4-BE49-F238E27FC236}">
                    <a16:creationId xmlns:a16="http://schemas.microsoft.com/office/drawing/2014/main" id="{FDF6C2E6-57E1-ABAE-BA38-254DBFABD1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9" y="3128"/>
                <a:ext cx="8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</a:t>
                </a:r>
              </a:p>
            </p:txBody>
          </p:sp>
          <p:sp>
            <p:nvSpPr>
              <p:cNvPr id="70" name="Rectangle 61">
                <a:extLst>
                  <a:ext uri="{FF2B5EF4-FFF2-40B4-BE49-F238E27FC236}">
                    <a16:creationId xmlns:a16="http://schemas.microsoft.com/office/drawing/2014/main" id="{591E886B-555B-786F-FD7D-93D32F1758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6" y="2954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1" name="Rectangle 62">
                <a:extLst>
                  <a:ext uri="{FF2B5EF4-FFF2-40B4-BE49-F238E27FC236}">
                    <a16:creationId xmlns:a16="http://schemas.microsoft.com/office/drawing/2014/main" id="{49BDEC46-C83C-4AE9-3EB3-BC62F94C3E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3" y="2419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72" name="Rectangle 63">
                <a:extLst>
                  <a:ext uri="{FF2B5EF4-FFF2-40B4-BE49-F238E27FC236}">
                    <a16:creationId xmlns:a16="http://schemas.microsoft.com/office/drawing/2014/main" id="{68BA72BB-D984-2854-41F8-E807DB69BC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1" y="1881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3" name="Rectangle 64">
                <a:extLst>
                  <a:ext uri="{FF2B5EF4-FFF2-40B4-BE49-F238E27FC236}">
                    <a16:creationId xmlns:a16="http://schemas.microsoft.com/office/drawing/2014/main" id="{9461880C-8721-ADBA-9987-CE0EF4CF4F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8" y="134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74" name="Rectangle 65">
                <a:extLst>
                  <a:ext uri="{FF2B5EF4-FFF2-40B4-BE49-F238E27FC236}">
                    <a16:creationId xmlns:a16="http://schemas.microsoft.com/office/drawing/2014/main" id="{8DC47267-30D1-971C-1031-9DD2297E3D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5" y="812"/>
                <a:ext cx="10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75" name="Line 66">
                <a:extLst>
                  <a:ext uri="{FF2B5EF4-FFF2-40B4-BE49-F238E27FC236}">
                    <a16:creationId xmlns:a16="http://schemas.microsoft.com/office/drawing/2014/main" id="{D501F74F-83C5-CDCD-352D-D0A7D66FB6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2994"/>
                <a:ext cx="15" cy="0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" name="Line 67">
                <a:extLst>
                  <a:ext uri="{FF2B5EF4-FFF2-40B4-BE49-F238E27FC236}">
                    <a16:creationId xmlns:a16="http://schemas.microsoft.com/office/drawing/2014/main" id="{1DD14020-03C0-0D05-F12D-2CC0C8F1AA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2458"/>
                <a:ext cx="15" cy="0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" name="Line 68">
                <a:extLst>
                  <a:ext uri="{FF2B5EF4-FFF2-40B4-BE49-F238E27FC236}">
                    <a16:creationId xmlns:a16="http://schemas.microsoft.com/office/drawing/2014/main" id="{E334E7CB-740F-42FC-DD45-1476A63017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1922"/>
                <a:ext cx="15" cy="0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" name="Line 69">
                <a:extLst>
                  <a:ext uri="{FF2B5EF4-FFF2-40B4-BE49-F238E27FC236}">
                    <a16:creationId xmlns:a16="http://schemas.microsoft.com/office/drawing/2014/main" id="{338DAC2E-8E0A-2940-B4AB-58E620E38C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1387"/>
                <a:ext cx="15" cy="0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" name="Line 70">
                <a:extLst>
                  <a:ext uri="{FF2B5EF4-FFF2-40B4-BE49-F238E27FC236}">
                    <a16:creationId xmlns:a16="http://schemas.microsoft.com/office/drawing/2014/main" id="{FAD63B12-DA21-4319-81AB-503EC48EB4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851"/>
                <a:ext cx="15" cy="0"/>
              </a:xfrm>
              <a:prstGeom prst="line">
                <a:avLst/>
              </a:prstGeom>
              <a:noFill/>
              <a:ln w="635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" name="Rectangle 71">
                <a:extLst>
                  <a:ext uri="{FF2B5EF4-FFF2-40B4-BE49-F238E27FC236}">
                    <a16:creationId xmlns:a16="http://schemas.microsoft.com/office/drawing/2014/main" id="{51DCA9F2-ECB8-3815-9E3F-9B75807F8C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4" y="3234"/>
                <a:ext cx="66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orage </a:t>
                </a:r>
                <a:r>
                  <a:rPr kumimoji="0" lang="it-IT" altLang="it-IT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ditions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Rectangle 72">
                <a:extLst>
                  <a:ext uri="{FF2B5EF4-FFF2-40B4-BE49-F238E27FC236}">
                    <a16:creationId xmlns:a16="http://schemas.microsoft.com/office/drawing/2014/main" id="{33166E42-1911-2BE8-E7C3-B8C9264FA6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720" y="1867"/>
                <a:ext cx="75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ald</a:t>
                </a:r>
                <a:r>
                  <a:rPr kumimoji="0" lang="it-IT" altLang="it-IT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it-IT" altLang="it-IT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</a:t>
                </a:r>
                <a:r>
                  <a:rPr kumimoji="0" lang="it-IT" altLang="it-IT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)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Rectangle 73">
                <a:extLst>
                  <a:ext uri="{FF2B5EF4-FFF2-40B4-BE49-F238E27FC236}">
                    <a16:creationId xmlns:a16="http://schemas.microsoft.com/office/drawing/2014/main" id="{3BC2FC3E-4A09-6B07-9562-71B5D6C61A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1" y="510"/>
                <a:ext cx="1409" cy="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2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ald</a:t>
                </a:r>
                <a:r>
                  <a:rPr kumimoji="0" lang="it-IT" altLang="it-IT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it-IT" altLang="it-IT" sz="12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velopment</a:t>
                </a:r>
                <a:r>
                  <a:rPr kumimoji="0" lang="it-IT" altLang="it-IT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uring storage</a:t>
                </a:r>
                <a:endParaRPr kumimoji="0" lang="it-IT" altLang="it-IT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3" name="Rettangolo 82">
              <a:extLst>
                <a:ext uri="{FF2B5EF4-FFF2-40B4-BE49-F238E27FC236}">
                  <a16:creationId xmlns:a16="http://schemas.microsoft.com/office/drawing/2014/main" id="{1D6E2A58-ECA1-4C1F-FEF4-3E449342CCAF}"/>
                </a:ext>
              </a:extLst>
            </p:cNvPr>
            <p:cNvSpPr/>
            <p:nvPr/>
          </p:nvSpPr>
          <p:spPr>
            <a:xfrm>
              <a:off x="4199770" y="1189697"/>
              <a:ext cx="72000" cy="72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84" name="Rettangolo 83">
              <a:extLst>
                <a:ext uri="{FF2B5EF4-FFF2-40B4-BE49-F238E27FC236}">
                  <a16:creationId xmlns:a16="http://schemas.microsoft.com/office/drawing/2014/main" id="{565B9858-CA60-19D1-D4E6-A543B29FE6C9}"/>
                </a:ext>
              </a:extLst>
            </p:cNvPr>
            <p:cNvSpPr/>
            <p:nvPr/>
          </p:nvSpPr>
          <p:spPr>
            <a:xfrm>
              <a:off x="6680492" y="1187390"/>
              <a:ext cx="72000" cy="7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85" name="TextBox 20">
            <a:extLst>
              <a:ext uri="{FF2B5EF4-FFF2-40B4-BE49-F238E27FC236}">
                <a16:creationId xmlns:a16="http://schemas.microsoft.com/office/drawing/2014/main" id="{09722A56-E885-92C8-1929-0D5238761F22}"/>
              </a:ext>
            </a:extLst>
          </p:cNvPr>
          <p:cNvSpPr txBox="1"/>
          <p:nvPr/>
        </p:nvSpPr>
        <p:spPr>
          <a:xfrm>
            <a:off x="228599" y="97038"/>
            <a:ext cx="18132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2</a:t>
            </a:r>
          </a:p>
          <a:p>
            <a:pPr defTabSz="457189"/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42090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65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orenzo vittani</dc:creator>
  <cp:lastModifiedBy>Costa Fabrizio</cp:lastModifiedBy>
  <cp:revision>3</cp:revision>
  <dcterms:created xsi:type="dcterms:W3CDTF">2023-02-20T17:00:33Z</dcterms:created>
  <dcterms:modified xsi:type="dcterms:W3CDTF">2023-02-21T13:26:34Z</dcterms:modified>
</cp:coreProperties>
</file>